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  <p:sldId id="260" r:id="rId4"/>
    <p:sldId id="261" r:id="rId5"/>
    <p:sldId id="262" r:id="rId6"/>
  </p:sldIdLst>
  <p:sldSz cx="6858000" cy="9906000" type="A4"/>
  <p:notesSz cx="6858000" cy="91440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BEB35"/>
    <a:srgbClr val="595959"/>
    <a:srgbClr val="A5A5A5"/>
    <a:srgbClr val="DCEAC4"/>
    <a:srgbClr val="CC8758"/>
    <a:srgbClr val="D6E6CC"/>
    <a:srgbClr val="CFE2D5"/>
    <a:srgbClr val="BBD6ED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ittlere Formatvorlage 2 - Akz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118" autoAdjust="0"/>
    <p:restoredTop sz="94660"/>
  </p:normalViewPr>
  <p:slideViewPr>
    <p:cSldViewPr snapToGrid="0">
      <p:cViewPr varScale="1">
        <p:scale>
          <a:sx n="73" d="100"/>
          <a:sy n="73" d="100"/>
        </p:scale>
        <p:origin x="-1212" y="-10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5F4FFD-BD2E-4B3D-B6E9-9140AB0B4425}" type="datetimeFigureOut">
              <a:rPr lang="de-DE"/>
              <a:pPr>
                <a:defRPr/>
              </a:pPr>
              <a:t>09.05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797AFA-7D4C-41B3-B47B-C4FB6348CC6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3DFFEDD-FF3C-4D6C-B12B-6C01B1F779ED}" type="datetimeFigureOut">
              <a:rPr lang="de-DE"/>
              <a:pPr>
                <a:defRPr/>
              </a:pPr>
              <a:t>09.05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8473F1-7A76-4E43-8D53-505B2F30E6B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705CD6-3362-4580-A929-9ACFE38CC477}" type="datetimeFigureOut">
              <a:rPr lang="de-DE"/>
              <a:pPr>
                <a:defRPr/>
              </a:pPr>
              <a:t>09.05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34580F6-589B-482C-A941-916A0FEDF322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30FEC0-EDA9-4DD3-A25D-4B77278E7ACF}" type="datetimeFigureOut">
              <a:rPr lang="de-DE"/>
              <a:pPr>
                <a:defRPr/>
              </a:pPr>
              <a:t>09.05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E7BCAA-FE74-4D4C-8C2A-A997F52D590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03FC6B-D635-4332-A3B2-598738DD30EF}" type="datetimeFigureOut">
              <a:rPr lang="de-DE"/>
              <a:pPr>
                <a:defRPr/>
              </a:pPr>
              <a:t>09.05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2F1144-CCE1-41F9-B689-44548E5F0BD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3DC6A4-A471-4DE1-B485-626C4D2F917F}" type="datetimeFigureOut">
              <a:rPr lang="de-DE"/>
              <a:pPr>
                <a:defRPr/>
              </a:pPr>
              <a:t>09.05.2019</a:t>
            </a:fld>
            <a:endParaRPr 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3786D5-B2F6-4B12-83C9-4C899457A7AC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58AE2D-0CE3-42A2-856B-AB511E14EC1E}" type="datetimeFigureOut">
              <a:rPr lang="de-DE"/>
              <a:pPr>
                <a:defRPr/>
              </a:pPr>
              <a:t>09.05.2019</a:t>
            </a:fld>
            <a:endParaRPr lang="de-DE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1DE841-1952-4123-BD44-A8FBA47C295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79563F-AEBF-48F3-8BDE-9E25C04D1A6F}" type="datetimeFigureOut">
              <a:rPr lang="de-DE"/>
              <a:pPr>
                <a:defRPr/>
              </a:pPr>
              <a:t>09.05.2019</a:t>
            </a:fld>
            <a:endParaRPr lang="de-DE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5B8A01-1DB1-4DEC-87D9-19478F476EF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F20F79-5CDB-42E5-8094-381D03DDFB21}" type="datetimeFigureOut">
              <a:rPr lang="de-DE"/>
              <a:pPr>
                <a:defRPr/>
              </a:pPr>
              <a:t>09.05.2019</a:t>
            </a:fld>
            <a:endParaRPr lang="de-DE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F8F8A4-0648-42CC-AE8A-E59BB08DE5B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6670DA-0C15-47BE-9D02-5B8355161492}" type="datetimeFigureOut">
              <a:rPr lang="de-DE"/>
              <a:pPr>
                <a:defRPr/>
              </a:pPr>
              <a:t>09.05.2019</a:t>
            </a:fld>
            <a:endParaRPr 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9D491E-6BCD-4015-B9CF-D8CED75DC49C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de-DE" noProof="0" smtClean="0"/>
              <a:t>Bild durch Klicken auf Symbol hinzufügen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36DA906-A87A-400E-9F03-9F1C3FD9B50E}" type="datetimeFigureOut">
              <a:rPr lang="de-DE"/>
              <a:pPr>
                <a:defRPr/>
              </a:pPr>
              <a:t>09.05.2019</a:t>
            </a:fld>
            <a:endParaRPr 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C3D4F1-25CD-4203-A63A-A2FA25F8B41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71488" y="527050"/>
            <a:ext cx="5915025" cy="1914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  <a:endParaRPr lang="en-US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71488" y="2636838"/>
            <a:ext cx="5915025" cy="6284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49EAE684-8E77-4728-A35E-7B95915EC778}" type="datetimeFigureOut">
              <a:rPr lang="de-DE"/>
              <a:pPr>
                <a:defRPr/>
              </a:pPr>
              <a:t>09.05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3F145219-BA88-408F-BBDE-7B4735FCD7A9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1" r:id="rId1"/>
    <p:sldLayoutId id="2147483670" r:id="rId2"/>
    <p:sldLayoutId id="2147483669" r:id="rId3"/>
    <p:sldLayoutId id="2147483668" r:id="rId4"/>
    <p:sldLayoutId id="2147483667" r:id="rId5"/>
    <p:sldLayoutId id="2147483666" r:id="rId6"/>
    <p:sldLayoutId id="2147483665" r:id="rId7"/>
    <p:sldLayoutId id="2147483664" r:id="rId8"/>
    <p:sldLayoutId id="2147483663" r:id="rId9"/>
    <p:sldLayoutId id="2147483662" r:id="rId10"/>
    <p:sldLayoutId id="2147483661" r:id="rId11"/>
  </p:sldLayoutIdLst>
  <p:txStyles>
    <p:titleStyle>
      <a:lvl1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</a:defRPr>
      </a:lvl2pPr>
      <a:lvl3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</a:defRPr>
      </a:lvl3pPr>
      <a:lvl4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</a:defRPr>
      </a:lvl4pPr>
      <a:lvl5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</a:defRPr>
      </a:lvl9pPr>
    </p:titleStyle>
    <p:bodyStyle>
      <a:lvl1pPr marL="171450" indent="-171450" algn="l" defTabSz="685800" rtl="0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614" name="Group 302"/>
          <p:cNvGraphicFramePr>
            <a:graphicFrameLocks noGrp="1"/>
          </p:cNvGraphicFramePr>
          <p:nvPr/>
        </p:nvGraphicFramePr>
        <p:xfrm>
          <a:off x="514350" y="2557463"/>
          <a:ext cx="5799138" cy="6307137"/>
        </p:xfrm>
        <a:graphic>
          <a:graphicData uri="http://schemas.openxmlformats.org/drawingml/2006/table">
            <a:tbl>
              <a:tblPr/>
              <a:tblGrid>
                <a:gridCol w="682625"/>
                <a:gridCol w="738188"/>
                <a:gridCol w="739775"/>
                <a:gridCol w="738187"/>
                <a:gridCol w="739775"/>
                <a:gridCol w="681038"/>
                <a:gridCol w="739775"/>
                <a:gridCol w="739775"/>
              </a:tblGrid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8, n=10</a:t>
                      </a:r>
                      <a:endParaRPr kumimoji="0" lang="de-DE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ean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D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8, n=3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ean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D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a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191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313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d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078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122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b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053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262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v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061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06385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p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802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209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9, n=19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ean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D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9, n=12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ean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D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c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953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95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d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9238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259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b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966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096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v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054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191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p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283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99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018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10a, n=16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ean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D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10a, n=9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ean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D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c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830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38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d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9336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175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b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876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03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v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007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804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p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523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263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10b, n=46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ean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D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10b, n=46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ean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D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c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794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43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d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8998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013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b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934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096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v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078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09877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p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613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365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11, n=11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ean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D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11, n=10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ean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D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c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605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75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d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8462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231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b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118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75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v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171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7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p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575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352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12, n=11</a:t>
                      </a:r>
                      <a:endParaRPr kumimoji="0" lang="de-DE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ean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D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12, n=8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ean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D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c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561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234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d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8162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09681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b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025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32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v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297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101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pFC</a:t>
                      </a: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307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314</a:t>
                      </a: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9243" marR="9243" marT="924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3610" name="Textfeld 3"/>
          <p:cNvSpPr txBox="1">
            <a:spLocks noChangeArrowheads="1"/>
          </p:cNvSpPr>
          <p:nvPr/>
        </p:nvSpPr>
        <p:spPr bwMode="auto">
          <a:xfrm>
            <a:off x="449263" y="1928813"/>
            <a:ext cx="5888037" cy="428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de-DE" sz="1100" b="1">
                <a:latin typeface="Calibri" pitchFamily="34" charset="0"/>
              </a:rPr>
              <a:t>Table S1:</a:t>
            </a:r>
            <a:r>
              <a:rPr lang="de-DE" sz="1100">
                <a:latin typeface="Calibri" pitchFamily="34" charset="0"/>
              </a:rPr>
              <a:t> </a:t>
            </a:r>
            <a:r>
              <a:rPr lang="en-GB" sz="1100">
                <a:latin typeface="Calibri" pitchFamily="34" charset="0"/>
              </a:rPr>
              <a:t>Development of pH</a:t>
            </a:r>
            <a:r>
              <a:rPr lang="en-GB" sz="1100" baseline="-25000">
                <a:latin typeface="Calibri" pitchFamily="34" charset="0"/>
              </a:rPr>
              <a:t>i</a:t>
            </a:r>
            <a:r>
              <a:rPr lang="en-GB" sz="1100">
                <a:latin typeface="Calibri" pitchFamily="34" charset="0"/>
              </a:rPr>
              <a:t>-gradients in the FCE during S8-12 (CFDA; SIM). Numerical values corresponding to Fig. 1C. Left: a-p gradient. Right: d-v gradient.</a:t>
            </a:r>
            <a:endParaRPr lang="de-DE" sz="1100" baseline="-25000">
              <a:latin typeface="Calibri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Textfeld 2"/>
          <p:cNvSpPr txBox="1">
            <a:spLocks noChangeArrowheads="1"/>
          </p:cNvSpPr>
          <p:nvPr/>
        </p:nvSpPr>
        <p:spPr bwMode="auto">
          <a:xfrm>
            <a:off x="401638" y="1928813"/>
            <a:ext cx="6011862" cy="428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de-DE" sz="1100" b="1">
                <a:latin typeface="Calibri" pitchFamily="34" charset="0"/>
              </a:rPr>
              <a:t>Table S2:</a:t>
            </a:r>
            <a:r>
              <a:rPr lang="de-DE" sz="1100">
                <a:latin typeface="Calibri" pitchFamily="34" charset="0"/>
              </a:rPr>
              <a:t> </a:t>
            </a:r>
            <a:r>
              <a:rPr lang="en-GB" sz="1100">
                <a:latin typeface="Calibri" pitchFamily="34" charset="0"/>
              </a:rPr>
              <a:t>Development of V</a:t>
            </a:r>
            <a:r>
              <a:rPr lang="en-GB" sz="1100" baseline="-25000">
                <a:latin typeface="Calibri" pitchFamily="34" charset="0"/>
              </a:rPr>
              <a:t>mem</a:t>
            </a:r>
            <a:r>
              <a:rPr lang="en-GB" sz="1100">
                <a:latin typeface="Calibri" pitchFamily="34" charset="0"/>
              </a:rPr>
              <a:t>-gradients in the FCE during S8-12 (DiBAC; SIM). Numerical values corresponding to Fig. 2C. Left: a-p gradient. Right: d-v gradient.</a:t>
            </a:r>
            <a:endParaRPr lang="de-DE" sz="1100" baseline="-25000">
              <a:latin typeface="Calibri" pitchFamily="34" charset="0"/>
            </a:endParaRPr>
          </a:p>
        </p:txBody>
      </p:sp>
      <p:graphicFrame>
        <p:nvGraphicFramePr>
          <p:cNvPr id="4" name="Tabelle 3"/>
          <p:cNvGraphicFramePr>
            <a:graphicFrameLocks noGrp="1"/>
          </p:cNvGraphicFramePr>
          <p:nvPr/>
        </p:nvGraphicFramePr>
        <p:xfrm>
          <a:off x="471488" y="2636838"/>
          <a:ext cx="5915025" cy="6284912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739378"/>
                <a:gridCol w="739378"/>
                <a:gridCol w="739378"/>
                <a:gridCol w="739378"/>
                <a:gridCol w="739378"/>
                <a:gridCol w="739378"/>
                <a:gridCol w="739378"/>
                <a:gridCol w="739378"/>
              </a:tblGrid>
              <a:tr h="18484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S8, n=7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u="none" strike="noStrike" dirty="0">
                          <a:effectLst/>
                        </a:rPr>
                        <a:t>Mean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u="none" strike="noStrike">
                          <a:effectLst/>
                        </a:rPr>
                        <a:t>SD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S8, n=4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u="none" strike="noStrike">
                          <a:effectLst/>
                        </a:rPr>
                        <a:t>Mean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u="none" strike="noStrike" dirty="0">
                          <a:effectLst/>
                        </a:rPr>
                        <a:t>SD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aFC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1,14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0,404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dFC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0,95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0,0753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mbFC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,10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0,474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vFC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1,04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0668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pFC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,18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560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S9, n=5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u="none" strike="noStrike" dirty="0">
                          <a:effectLst/>
                        </a:rPr>
                        <a:t>Mean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u="none" strike="noStrike" dirty="0">
                          <a:effectLst/>
                        </a:rPr>
                        <a:t>SD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S9, n=3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u="none" strike="noStrike">
                          <a:effectLst/>
                        </a:rPr>
                        <a:t>Mean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u="none" strike="noStrike" dirty="0">
                          <a:effectLst/>
                        </a:rPr>
                        <a:t>SD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cFC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,0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190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dFC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1,05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0,0571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mbFC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827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0947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vFC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955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0647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pFC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,15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216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S10a, n=14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u="none" strike="noStrike" dirty="0">
                          <a:effectLst/>
                        </a:rPr>
                        <a:t>Mean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u="none" strike="noStrike" dirty="0">
                          <a:effectLst/>
                        </a:rPr>
                        <a:t>SD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S10a, n=5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u="none" strike="noStrike">
                          <a:effectLst/>
                        </a:rPr>
                        <a:t>Mean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u="none" strike="noStrike" dirty="0">
                          <a:effectLst/>
                        </a:rPr>
                        <a:t>SD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cFC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941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261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dFC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963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0,19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mbFC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761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0747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vFC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1,05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0,235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pFC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,66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369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S10b, n=42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u="none" strike="noStrike">
                          <a:effectLst/>
                        </a:rPr>
                        <a:t>Mean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u="none" strike="noStrike">
                          <a:effectLst/>
                        </a:rPr>
                        <a:t>SD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S10b, n=42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u="none" strike="noStrike">
                          <a:effectLst/>
                        </a:rPr>
                        <a:t>Mean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u="none" strike="noStrike" dirty="0">
                          <a:effectLst/>
                        </a:rPr>
                        <a:t>SD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cFC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0,735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0,208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dFC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887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0,169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mbFC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872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103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vFC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1,12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0,191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pFC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,80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432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S11, n=12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u="none" strike="noStrike">
                          <a:effectLst/>
                        </a:rPr>
                        <a:t>Mean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u="none" strike="noStrike">
                          <a:effectLst/>
                        </a:rPr>
                        <a:t>SD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S11, n=9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u="none" strike="noStrike">
                          <a:effectLst/>
                        </a:rPr>
                        <a:t>Mean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u="none" strike="noStrike" dirty="0">
                          <a:effectLst/>
                        </a:rPr>
                        <a:t>SD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cFC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0,802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242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dFC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0,93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0,192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mbFC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911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138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vFC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,16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0,316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pFC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,66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79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S12, n=7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u="none" strike="noStrike" dirty="0">
                          <a:effectLst/>
                        </a:rPr>
                        <a:t>Mean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u="none" strike="noStrike" dirty="0">
                          <a:effectLst/>
                        </a:rPr>
                        <a:t>SD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S12, n=6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u="none" strike="noStrike" dirty="0">
                          <a:effectLst/>
                        </a:rPr>
                        <a:t>Mean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u="none" strike="noStrike" dirty="0">
                          <a:effectLst/>
                        </a:rPr>
                        <a:t>SD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cFC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856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0,349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>
                          <a:effectLst/>
                        </a:rPr>
                        <a:t>dFC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770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0,220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mbFC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852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127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vFC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1,21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30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</a:tr>
              <a:tr h="18484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C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,43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19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2" marR="9242" marT="9242" marB="0" anchor="b"/>
                </a:tc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elle 6"/>
          <p:cNvGraphicFramePr>
            <a:graphicFrameLocks noGrp="1"/>
          </p:cNvGraphicFramePr>
          <p:nvPr/>
        </p:nvGraphicFramePr>
        <p:xfrm>
          <a:off x="517525" y="2352675"/>
          <a:ext cx="5915025" cy="2046288"/>
        </p:xfrm>
        <a:graphic>
          <a:graphicData uri="http://schemas.openxmlformats.org/drawingml/2006/table">
            <a:tbl>
              <a:tblPr/>
              <a:tblGrid>
                <a:gridCol w="435152"/>
                <a:gridCol w="799465"/>
                <a:gridCol w="890543"/>
                <a:gridCol w="1022100"/>
                <a:gridCol w="812114"/>
                <a:gridCol w="1054989"/>
                <a:gridCol w="900662"/>
              </a:tblGrid>
              <a:tr h="151927"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miloride</a:t>
                      </a:r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, n=36</a:t>
                      </a:r>
                    </a:p>
                  </a:txBody>
                  <a:tcPr marL="7596" marR="7596" marT="759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filomycin, n=36</a:t>
                      </a:r>
                    </a:p>
                  </a:txBody>
                  <a:tcPr marL="7596" marR="7596" marT="759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ibenclamide, n=36</a:t>
                      </a:r>
                    </a:p>
                  </a:txBody>
                  <a:tcPr marL="7596" marR="7596" marT="759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erapamil, n=36</a:t>
                      </a:r>
                    </a:p>
                  </a:txBody>
                  <a:tcPr marL="7596" marR="7596" marT="759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-Anthroic </a:t>
                      </a:r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id, </a:t>
                      </a:r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=36</a:t>
                      </a:r>
                    </a:p>
                  </a:txBody>
                  <a:tcPr marL="7596" marR="7596" marT="759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urosemide</a:t>
                      </a:r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, n=36</a:t>
                      </a:r>
                    </a:p>
                  </a:txBody>
                  <a:tcPr marL="7596" marR="7596" marT="759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927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an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057</a:t>
                      </a:r>
                    </a:p>
                  </a:txBody>
                  <a:tcPr marL="7596" marR="7596" marT="759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979</a:t>
                      </a:r>
                    </a:p>
                  </a:txBody>
                  <a:tcPr marL="7596" marR="7596" marT="759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149</a:t>
                      </a:r>
                    </a:p>
                  </a:txBody>
                  <a:tcPr marL="7596" marR="7596" marT="759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531</a:t>
                      </a:r>
                    </a:p>
                  </a:txBody>
                  <a:tcPr marL="7596" marR="7596" marT="759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716</a:t>
                      </a:r>
                    </a:p>
                  </a:txBody>
                  <a:tcPr marL="7596" marR="7596" marT="759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,025</a:t>
                      </a:r>
                    </a:p>
                  </a:txBody>
                  <a:tcPr marL="7596" marR="7596" marT="759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51927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D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360</a:t>
                      </a:r>
                    </a:p>
                  </a:txBody>
                  <a:tcPr marL="7596" marR="7596" marT="759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326</a:t>
                      </a:r>
                    </a:p>
                  </a:txBody>
                  <a:tcPr marL="7596" marR="7596" marT="759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448</a:t>
                      </a:r>
                    </a:p>
                  </a:txBody>
                  <a:tcPr marL="7596" marR="7596" marT="759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740</a:t>
                      </a:r>
                    </a:p>
                  </a:txBody>
                  <a:tcPr marL="7596" marR="7596" marT="759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689</a:t>
                      </a:r>
                    </a:p>
                  </a:txBody>
                  <a:tcPr marL="7596" marR="7596" marT="759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152</a:t>
                      </a:r>
                    </a:p>
                  </a:txBody>
                  <a:tcPr marL="7596" marR="7596" marT="759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927"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927"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fontAlgn="b"/>
                      <a:endParaRPr lang="de-DE" sz="9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fontAlgn="b"/>
                      <a:endParaRPr lang="de-DE" sz="9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fontAlgn="b"/>
                      <a:endParaRPr lang="de-DE" sz="9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fontAlgn="b"/>
                      <a:endParaRPr lang="de-DE" sz="9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927"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927"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miloride, n=36</a:t>
                      </a:r>
                    </a:p>
                  </a:txBody>
                  <a:tcPr marL="7596" marR="7596" marT="759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filomycin, n=36</a:t>
                      </a:r>
                    </a:p>
                  </a:txBody>
                  <a:tcPr marL="7596" marR="7596" marT="759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ibenclamide, n=36</a:t>
                      </a:r>
                    </a:p>
                  </a:txBody>
                  <a:tcPr marL="7596" marR="7596" marT="759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erapamil, n=36</a:t>
                      </a:r>
                    </a:p>
                  </a:txBody>
                  <a:tcPr marL="7596" marR="7596" marT="759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-Anthroic </a:t>
                      </a:r>
                      <a:r>
                        <a:rPr lang="de-DE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id, </a:t>
                      </a:r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=36</a:t>
                      </a:r>
                    </a:p>
                  </a:txBody>
                  <a:tcPr marL="7596" marR="7596" marT="759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urosemide</a:t>
                      </a:r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, n=36</a:t>
                      </a:r>
                    </a:p>
                  </a:txBody>
                  <a:tcPr marL="7596" marR="7596" marT="759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927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an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89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96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93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62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87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88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51927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D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15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7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23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12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8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11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15440" name="Textfeld 4"/>
          <p:cNvSpPr txBox="1">
            <a:spLocks noChangeArrowheads="1"/>
          </p:cNvSpPr>
          <p:nvPr/>
        </p:nvSpPr>
        <p:spPr bwMode="auto">
          <a:xfrm>
            <a:off x="428625" y="1835150"/>
            <a:ext cx="6080125" cy="4302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de-DE" sz="1100" b="1">
                <a:latin typeface="Calibri" pitchFamily="34" charset="0"/>
              </a:rPr>
              <a:t>Table S3:</a:t>
            </a:r>
            <a:r>
              <a:rPr lang="de-DE" sz="1100">
                <a:latin typeface="Calibri" pitchFamily="34" charset="0"/>
              </a:rPr>
              <a:t> </a:t>
            </a:r>
            <a:r>
              <a:rPr lang="en-GB" sz="1100">
                <a:latin typeface="Calibri" pitchFamily="34" charset="0"/>
                <a:cs typeface="Times New Roman" pitchFamily="18" charset="0"/>
              </a:rPr>
              <a:t>Inhibitors of ion-transport mechanisms exert influence on the pH</a:t>
            </a:r>
            <a:r>
              <a:rPr lang="en-GB" sz="1100" baseline="-25000">
                <a:latin typeface="Calibri" pitchFamily="34" charset="0"/>
                <a:cs typeface="Times New Roman" pitchFamily="18" charset="0"/>
              </a:rPr>
              <a:t>i</a:t>
            </a:r>
            <a:r>
              <a:rPr lang="en-GB" sz="1100">
                <a:latin typeface="Calibri" pitchFamily="34" charset="0"/>
                <a:cs typeface="Times New Roman" pitchFamily="18" charset="0"/>
              </a:rPr>
              <a:t> in the FCE during S10b (WFM-experiment; CFDA). </a:t>
            </a:r>
            <a:r>
              <a:rPr lang="en-GB" sz="1100">
                <a:latin typeface="Calibri" pitchFamily="34" charset="0"/>
              </a:rPr>
              <a:t>Numerical values corresponding to Fig. 3A. </a:t>
            </a:r>
            <a:endParaRPr lang="de-DE" sz="1100" baseline="-25000">
              <a:latin typeface="Calibri" pitchFamily="34" charset="0"/>
            </a:endParaRPr>
          </a:p>
        </p:txBody>
      </p:sp>
      <p:sp>
        <p:nvSpPr>
          <p:cNvPr id="15441" name="Textfeld 3"/>
          <p:cNvSpPr txBox="1">
            <a:spLocks noChangeArrowheads="1"/>
          </p:cNvSpPr>
          <p:nvPr/>
        </p:nvSpPr>
        <p:spPr bwMode="auto">
          <a:xfrm>
            <a:off x="428625" y="3416300"/>
            <a:ext cx="6080125" cy="4302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de-DE" sz="1100" b="1">
                <a:latin typeface="Calibri" pitchFamily="34" charset="0"/>
              </a:rPr>
              <a:t>Table S4:</a:t>
            </a:r>
            <a:r>
              <a:rPr lang="de-DE" sz="1100">
                <a:latin typeface="Calibri" pitchFamily="34" charset="0"/>
              </a:rPr>
              <a:t> </a:t>
            </a:r>
            <a:r>
              <a:rPr lang="en-GB" sz="1100">
                <a:latin typeface="Calibri" pitchFamily="34" charset="0"/>
                <a:cs typeface="Times New Roman" pitchFamily="18" charset="0"/>
              </a:rPr>
              <a:t>Inhibitors of ion-transport mechanisms exert influence on the V</a:t>
            </a:r>
            <a:r>
              <a:rPr lang="en-GB" sz="1100" baseline="-25000">
                <a:latin typeface="Calibri" pitchFamily="34" charset="0"/>
                <a:cs typeface="Times New Roman" pitchFamily="18" charset="0"/>
              </a:rPr>
              <a:t>mem</a:t>
            </a:r>
            <a:r>
              <a:rPr lang="en-GB" sz="1100">
                <a:latin typeface="Calibri" pitchFamily="34" charset="0"/>
                <a:cs typeface="Times New Roman" pitchFamily="18" charset="0"/>
              </a:rPr>
              <a:t> in the FCE during S10b (WFM-experiment; DiBAC). </a:t>
            </a:r>
            <a:r>
              <a:rPr lang="en-GB" sz="1100">
                <a:latin typeface="Calibri" pitchFamily="34" charset="0"/>
              </a:rPr>
              <a:t>Numerical values corresponding to Fig. 6A. </a:t>
            </a:r>
            <a:endParaRPr lang="de-DE" sz="1100" baseline="-25000">
              <a:latin typeface="Calibri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841" name="Group 529"/>
          <p:cNvGraphicFramePr>
            <a:graphicFrameLocks noGrp="1"/>
          </p:cNvGraphicFramePr>
          <p:nvPr/>
        </p:nvGraphicFramePr>
        <p:xfrm>
          <a:off x="604838" y="2139950"/>
          <a:ext cx="6110287" cy="5956300"/>
        </p:xfrm>
        <a:graphic>
          <a:graphicData uri="http://schemas.openxmlformats.org/drawingml/2006/table">
            <a:tbl>
              <a:tblPr/>
              <a:tblGrid>
                <a:gridCol w="376237"/>
                <a:gridCol w="100013"/>
                <a:gridCol w="446087"/>
                <a:gridCol w="393700"/>
                <a:gridCol w="161925"/>
                <a:gridCol w="446088"/>
                <a:gridCol w="463550"/>
                <a:gridCol w="188912"/>
                <a:gridCol w="496888"/>
                <a:gridCol w="293687"/>
                <a:gridCol w="88900"/>
                <a:gridCol w="446088"/>
                <a:gridCol w="393700"/>
                <a:gridCol w="142875"/>
                <a:gridCol w="446087"/>
                <a:gridCol w="627942"/>
                <a:gridCol w="173037"/>
                <a:gridCol w="423863"/>
              </a:tblGrid>
              <a:tr h="196850"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ean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D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ean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D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ean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D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ean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SD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DMSO, n=19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Amiloride, n=25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DMSO, n=18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Amiloride, n=18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c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484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92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420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260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d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824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246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662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237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b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541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44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439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260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v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000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273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748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290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p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000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327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682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416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DMSO, n=27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Bafilomycin, n=28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DMSO, n=16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Bafilomycin, n=22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c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634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204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064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554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d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954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285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2,000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100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b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649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82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144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613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v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122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359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2,554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427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p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000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333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2,052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185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DMSO, n=25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Glibenclamide, n=31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DMSO, n=12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Glibenclamide, n=10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c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541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205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3,911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26,752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d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733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258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4,897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3,907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b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617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223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5,994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29,844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v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000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475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6,054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3,389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p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000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313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23,810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38,380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Ethanol, n=22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Verapamil, n=29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Ethanol, n=7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Verapamil, n=10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c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406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78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782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546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d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767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205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2,124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231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b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548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208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043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741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v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000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097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2,465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617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p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000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516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971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465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765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Ethanol, n=40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9-Anthroic Acid, n=47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Ethanol, n=19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9-Anthroic Acid, n=21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c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484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90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762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331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d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841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380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717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326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b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586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276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117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627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v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000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449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742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653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p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000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561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784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178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DMSO, n=36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Furosemide, n=27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DMSO, n=19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Furosemide, n=18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c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928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73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3,586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1,653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d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964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82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26,558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8,700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mb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942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60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22,539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9,447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v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000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93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30,182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21,300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685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pFC</a:t>
                      </a: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1,000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0,156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45,524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de-DE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25,145</a:t>
                      </a: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de-DE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7583" marR="7583" marT="7583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6908" name="Textfeld 3"/>
          <p:cNvSpPr txBox="1">
            <a:spLocks noChangeArrowheads="1"/>
          </p:cNvSpPr>
          <p:nvPr/>
        </p:nvSpPr>
        <p:spPr bwMode="auto">
          <a:xfrm>
            <a:off x="528638" y="1317625"/>
            <a:ext cx="5770562" cy="596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de-DE" sz="1100" b="1">
                <a:latin typeface="Calibri" pitchFamily="34" charset="0"/>
              </a:rPr>
              <a:t>Table S5:</a:t>
            </a:r>
            <a:r>
              <a:rPr lang="de-DE" sz="1100">
                <a:latin typeface="Calibri" pitchFamily="34" charset="0"/>
              </a:rPr>
              <a:t> </a:t>
            </a:r>
            <a:r>
              <a:rPr lang="en-GB" sz="1100">
                <a:latin typeface="Calibri" pitchFamily="34" charset="0"/>
              </a:rPr>
              <a:t>The a-p and d-v pH</a:t>
            </a:r>
            <a:r>
              <a:rPr lang="en-GB" sz="1100" baseline="-25000">
                <a:latin typeface="Calibri" pitchFamily="34" charset="0"/>
              </a:rPr>
              <a:t>i</a:t>
            </a:r>
            <a:r>
              <a:rPr lang="en-GB" sz="1100">
                <a:latin typeface="Calibri" pitchFamily="34" charset="0"/>
              </a:rPr>
              <a:t>-gradients in the FCE are affected by all inhibitors in S10b (SIM-experiment; CFDA). Numerical values corresponding to Figs. 4B and 5A. Left: a-p gradient. Right: d-v gradient.</a:t>
            </a:r>
            <a:endParaRPr lang="de-DE" sz="1100" baseline="-25000">
              <a:latin typeface="Calibri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/>
        </p:nvGraphicFramePr>
        <p:xfrm>
          <a:off x="566738" y="2490788"/>
          <a:ext cx="5915025" cy="5545137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366046"/>
                <a:gridCol w="98601"/>
                <a:gridCol w="435145"/>
                <a:gridCol w="383518"/>
                <a:gridCol w="147507"/>
                <a:gridCol w="435145"/>
                <a:gridCol w="383518"/>
                <a:gridCol w="240641"/>
                <a:gridCol w="369054"/>
                <a:gridCol w="199134"/>
                <a:gridCol w="289062"/>
                <a:gridCol w="84622"/>
                <a:gridCol w="435145"/>
                <a:gridCol w="383518"/>
                <a:gridCol w="147507"/>
                <a:gridCol w="435145"/>
                <a:gridCol w="383518"/>
                <a:gridCol w="245095"/>
                <a:gridCol w="453104"/>
              </a:tblGrid>
              <a:tr h="184844">
                <a:tc rowSpan="2">
                  <a:txBody>
                    <a:bodyPr/>
                    <a:lstStyle/>
                    <a:p>
                      <a:pPr algn="r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1" u="none" strike="noStrike" dirty="0">
                          <a:effectLst/>
                        </a:rPr>
                        <a:t>Mean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1" u="none" strike="noStrike">
                          <a:effectLst/>
                        </a:rPr>
                        <a:t>SD</a:t>
                      </a:r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1" u="none" strike="noStrike" dirty="0">
                          <a:effectLst/>
                        </a:rPr>
                        <a:t>Mean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1" u="none" strike="noStrike" dirty="0">
                          <a:effectLst/>
                        </a:rPr>
                        <a:t>SD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 rowSpan="2">
                  <a:txBody>
                    <a:bodyPr/>
                    <a:lstStyle/>
                    <a:p>
                      <a:pPr algn="r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1" u="none" strike="noStrike" dirty="0">
                          <a:effectLst/>
                        </a:rPr>
                        <a:t>Mean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1" u="none" strike="noStrike">
                          <a:effectLst/>
                        </a:rPr>
                        <a:t>SD</a:t>
                      </a:r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1" u="none" strike="noStrike">
                          <a:effectLst/>
                        </a:rPr>
                        <a:t>Mean</a:t>
                      </a:r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1" u="none" strike="noStrike" dirty="0">
                          <a:effectLst/>
                        </a:rPr>
                        <a:t>SD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 vMerge="1"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DMSO, n=33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Amiloride, n=35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 vMerge="1"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DMSO, n=20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Amiloride, n=16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cFC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</a:rPr>
                        <a:t>0,40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</a:rPr>
                        <a:t>0,15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369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176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dFC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843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5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719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35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mbFC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</a:rPr>
                        <a:t>0,49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156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</a:rPr>
                        <a:t>0,41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173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vFC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1,00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77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921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187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pFC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</a:rPr>
                        <a:t>1,0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81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91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34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 gridSpan="2"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 err="1">
                          <a:effectLst/>
                        </a:rPr>
                        <a:t>DMSO,n</a:t>
                      </a:r>
                      <a:r>
                        <a:rPr lang="de-DE" sz="900" b="1" u="none" strike="noStrike" dirty="0">
                          <a:effectLst/>
                        </a:rPr>
                        <a:t>=22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Bafilomycin, n=20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DMSO, n=15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Bafilomycin, n=13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>
                          <a:effectLst/>
                        </a:rPr>
                        <a:t>cFC</a:t>
                      </a:r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</a:rPr>
                        <a:t>0,34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126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364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</a:rPr>
                        <a:t>0,20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dFC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</a:rPr>
                        <a:t>0,87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</a:rPr>
                        <a:t>0,19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807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425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>
                          <a:effectLst/>
                        </a:rPr>
                        <a:t>mbFC</a:t>
                      </a:r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427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117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45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18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vFC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1,00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187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1,024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568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pFC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1,00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34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89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</a:rPr>
                        <a:t>0,47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 gridSpan="2"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DMSO, n=23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Glibenclamide, n=29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DMSO, n=20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Glibenclamide, n=18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cFC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363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12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15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107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>
                          <a:effectLst/>
                        </a:rPr>
                        <a:t>dFC</a:t>
                      </a:r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</a:rPr>
                        <a:t>0,77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46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465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08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>
                          <a:effectLst/>
                        </a:rPr>
                        <a:t>mbFC</a:t>
                      </a:r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429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164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54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14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vFC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</a:rPr>
                        <a:t>1,0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</a:rPr>
                        <a:t>0,23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49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196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>
                          <a:effectLst/>
                        </a:rPr>
                        <a:t>pFC</a:t>
                      </a:r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1,00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8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521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87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 gridSpan="2"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Ethanol, n=34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Verapamil, n=36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Ethanol, n=21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 smtClean="0">
                          <a:effectLst/>
                        </a:rPr>
                        <a:t>Verapamil</a:t>
                      </a:r>
                      <a:r>
                        <a:rPr lang="de-DE" sz="900" b="1" u="none" strike="noStrike" dirty="0">
                          <a:effectLst/>
                        </a:rPr>
                        <a:t>, n=22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>
                          <a:effectLst/>
                        </a:rPr>
                        <a:t>cFC</a:t>
                      </a:r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412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189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166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114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>
                          <a:effectLst/>
                        </a:rPr>
                        <a:t>dFC</a:t>
                      </a:r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843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346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</a:rPr>
                        <a:t>0,33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169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mbFC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493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176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05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155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vFC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1,012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87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434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56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>
                          <a:effectLst/>
                        </a:rPr>
                        <a:t>pFC</a:t>
                      </a:r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1,00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392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364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19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 gridSpan="2"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Ethanol, n=23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9-Anthroic Acid, n=24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Ethanol, n=17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9-Anthroic Acid, n=24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cFC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589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25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541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38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>
                          <a:effectLst/>
                        </a:rPr>
                        <a:t>dFC</a:t>
                      </a:r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746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08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</a:rPr>
                        <a:t>0,85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</a:rPr>
                        <a:t>0,424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mbFC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585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34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553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51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>
                          <a:effectLst/>
                        </a:rPr>
                        <a:t>vFC</a:t>
                      </a:r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1,00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33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</a:rPr>
                        <a:t>0,86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392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pFC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1,00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89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796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36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 gridSpan="2"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DMSO, n=32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 err="1">
                          <a:effectLst/>
                        </a:rPr>
                        <a:t>Furosemide</a:t>
                      </a:r>
                      <a:r>
                        <a:rPr lang="de-DE" sz="900" b="1" u="none" strike="noStrike" dirty="0">
                          <a:effectLst/>
                        </a:rPr>
                        <a:t>, n=37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DMSO, n=13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 err="1">
                          <a:effectLst/>
                        </a:rPr>
                        <a:t>Furosemide</a:t>
                      </a:r>
                      <a:r>
                        <a:rPr lang="de-DE" sz="900" b="1" u="none" strike="noStrike" dirty="0">
                          <a:effectLst/>
                        </a:rPr>
                        <a:t>, n=19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cFC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48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158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372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54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dFC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</a:rPr>
                        <a:t>0,80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</a:rPr>
                        <a:t>0,25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825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462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>
                          <a:effectLst/>
                        </a:rPr>
                        <a:t>mbFC</a:t>
                      </a:r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52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178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389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79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vFC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</a:rPr>
                        <a:t>1,0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21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962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599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  <a:tr h="184844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pFC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>
                          <a:effectLst/>
                        </a:rPr>
                        <a:t>1,0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328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596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>
                          <a:effectLst/>
                        </a:rPr>
                        <a:t>0,412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94" marR="7394" marT="7394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4" marR="7394" marT="7394" marB="0" anchor="b"/>
                </a:tc>
              </a:tr>
            </a:tbl>
          </a:graphicData>
        </a:graphic>
      </p:graphicFrame>
      <p:sp>
        <p:nvSpPr>
          <p:cNvPr id="17944" name="Textfeld 4"/>
          <p:cNvSpPr txBox="1">
            <a:spLocks noChangeArrowheads="1"/>
          </p:cNvSpPr>
          <p:nvPr/>
        </p:nvSpPr>
        <p:spPr bwMode="auto">
          <a:xfrm>
            <a:off x="573088" y="1776413"/>
            <a:ext cx="5486400" cy="596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de-DE" sz="1100" b="1">
                <a:latin typeface="Calibri" pitchFamily="34" charset="0"/>
              </a:rPr>
              <a:t>Table S6:</a:t>
            </a:r>
            <a:r>
              <a:rPr lang="de-DE" sz="1100">
                <a:latin typeface="Calibri" pitchFamily="34" charset="0"/>
              </a:rPr>
              <a:t> </a:t>
            </a:r>
            <a:r>
              <a:rPr lang="en-GB" sz="1100">
                <a:latin typeface="Calibri" pitchFamily="34" charset="0"/>
              </a:rPr>
              <a:t>The a-p V</a:t>
            </a:r>
            <a:r>
              <a:rPr lang="en-GB" sz="1100" baseline="-25000">
                <a:latin typeface="Calibri" pitchFamily="34" charset="0"/>
              </a:rPr>
              <a:t>mem</a:t>
            </a:r>
            <a:r>
              <a:rPr lang="en-GB" sz="1100">
                <a:latin typeface="Calibri" pitchFamily="34" charset="0"/>
              </a:rPr>
              <a:t>-gradient in the FCE is affected by most inhibitors in S10b. </a:t>
            </a:r>
            <a:r>
              <a:rPr lang="en-US" sz="1100">
                <a:latin typeface="Calibri" pitchFamily="34" charset="0"/>
              </a:rPr>
              <a:t>Some inhibitors exert influence on the d-v V</a:t>
            </a:r>
            <a:r>
              <a:rPr lang="en-US" sz="1100" baseline="-25000">
                <a:latin typeface="Calibri" pitchFamily="34" charset="0"/>
              </a:rPr>
              <a:t>mem</a:t>
            </a:r>
            <a:r>
              <a:rPr lang="en-US" sz="1100">
                <a:latin typeface="Calibri" pitchFamily="34" charset="0"/>
              </a:rPr>
              <a:t>-gradient </a:t>
            </a:r>
            <a:r>
              <a:rPr lang="en-GB" sz="1100">
                <a:latin typeface="Calibri" pitchFamily="34" charset="0"/>
              </a:rPr>
              <a:t>(SIM-experiment; DiBAC). Numerical values corresponding to Figs. 7B and 8. Left: a-p gradient. Right: d-v gradient.</a:t>
            </a:r>
            <a:endParaRPr lang="de-DE" sz="1100" baseline="-25000">
              <a:latin typeface="Calibri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Larissa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13</Words>
  <Application>Microsoft Office PowerPoint</Application>
  <PresentationFormat>A4-Papier (210x297 mm)</PresentationFormat>
  <Paragraphs>666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Entwurfsvorlage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0" baseType="lpstr">
      <vt:lpstr>Arial</vt:lpstr>
      <vt:lpstr>Calibri Light</vt:lpstr>
      <vt:lpstr>Calibri</vt:lpstr>
      <vt:lpstr>Times New Roman</vt:lpstr>
      <vt:lpstr>Larissa</vt:lpstr>
      <vt:lpstr>Folie 1</vt:lpstr>
      <vt:lpstr>Folie 2</vt:lpstr>
      <vt:lpstr>Folie 3</vt:lpstr>
      <vt:lpstr>Folie 4</vt:lpstr>
      <vt:lpstr>Folie 5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Isa</dc:creator>
  <cp:lastModifiedBy>bohrmann</cp:lastModifiedBy>
  <cp:revision>210</cp:revision>
  <dcterms:created xsi:type="dcterms:W3CDTF">2018-06-11T13:11:53Z</dcterms:created>
  <dcterms:modified xsi:type="dcterms:W3CDTF">2019-05-09T17:19:00Z</dcterms:modified>
</cp:coreProperties>
</file>